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90" d="100"/>
          <a:sy n="90" d="100"/>
        </p:scale>
        <p:origin x="-3534" y="4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B5FA20-841F-4896-A981-4E0A884C1D28}" type="datetimeFigureOut">
              <a:rPr lang="de-AT" smtClean="0"/>
              <a:t>02.06.2016</a:t>
            </a:fld>
            <a:endParaRPr lang="de-AT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AT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DF9D7C-C101-44A0-845B-A16626ED5145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2236979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DF9D7C-C101-44A0-845B-A16626ED5145}" type="slidenum">
              <a:rPr lang="de-AT" smtClean="0"/>
              <a:t>1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6822787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2977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7501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34727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5531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1256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0311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6856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26727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1447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9326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5537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2660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815975" y="4999038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grpSp>
        <p:nvGrpSpPr>
          <p:cNvPr id="4" name="Gruppieren 3"/>
          <p:cNvGrpSpPr/>
          <p:nvPr/>
        </p:nvGrpSpPr>
        <p:grpSpPr>
          <a:xfrm>
            <a:off x="1617223" y="1388952"/>
            <a:ext cx="3404628" cy="6782090"/>
            <a:chOff x="1088740" y="449792"/>
            <a:chExt cx="4005445" cy="7978929"/>
          </a:xfrm>
        </p:grpSpPr>
        <p:pic>
          <p:nvPicPr>
            <p:cNvPr id="12" name="Picture 2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040" b="2346"/>
            <a:stretch/>
          </p:blipFill>
          <p:spPr bwMode="auto">
            <a:xfrm>
              <a:off x="1133744" y="449792"/>
              <a:ext cx="3960441" cy="263704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" name="Picture 2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999" b="2711"/>
            <a:stretch/>
          </p:blipFill>
          <p:spPr bwMode="auto">
            <a:xfrm>
              <a:off x="1124936" y="3109502"/>
              <a:ext cx="3969249" cy="26330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" name="Picture 2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340" b="2242"/>
            <a:stretch/>
          </p:blipFill>
          <p:spPr bwMode="auto">
            <a:xfrm>
              <a:off x="1117943" y="5787135"/>
              <a:ext cx="3976242" cy="26415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Textfeld 7"/>
            <p:cNvSpPr txBox="1"/>
            <p:nvPr/>
          </p:nvSpPr>
          <p:spPr>
            <a:xfrm>
              <a:off x="1125962" y="156094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2431461" y="155767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6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3701280" y="156624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9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1176104" y="485093"/>
              <a:ext cx="688311" cy="28967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A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mM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2521712" y="501832"/>
              <a:ext cx="560485" cy="28967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A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mM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3826813" y="501832"/>
              <a:ext cx="684954" cy="28967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A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5mM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1135995" y="4215233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0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2405716" y="421196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8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3699030" y="422053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6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1178749" y="3149185"/>
              <a:ext cx="791559" cy="28967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A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3mM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2503137" y="3149185"/>
              <a:ext cx="684954" cy="28967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A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1mM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3770508" y="3149185"/>
              <a:ext cx="767933" cy="28967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A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1mM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1148698" y="286609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2408969" y="286282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4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3701280" y="2871391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1114485" y="5514943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de-AT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de-A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2394239" y="551167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6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3689803" y="552024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7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1088740" y="6875963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4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2393885" y="687269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7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3803976" y="6881260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1206164" y="5832140"/>
              <a:ext cx="1088751" cy="28967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A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14% </a:t>
              </a:r>
              <a:r>
                <a:rPr lang="de-AT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tOH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feld 33"/>
            <p:cNvSpPr txBox="1"/>
            <p:nvPr/>
          </p:nvSpPr>
          <p:spPr>
            <a:xfrm>
              <a:off x="2501945" y="5832140"/>
              <a:ext cx="1187858" cy="28967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A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irus </a:t>
              </a:r>
              <a:r>
                <a:rPr lang="de-AT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feld 34"/>
            <p:cNvSpPr txBox="1"/>
            <p:nvPr/>
          </p:nvSpPr>
          <p:spPr>
            <a:xfrm>
              <a:off x="3802660" y="7137285"/>
              <a:ext cx="932251" cy="47071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AT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ibavirin</a:t>
              </a:r>
              <a:r>
                <a:rPr lang="de-A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de-AT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A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µg/ml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feld 35"/>
            <p:cNvSpPr txBox="1"/>
            <p:nvPr/>
          </p:nvSpPr>
          <p:spPr>
            <a:xfrm>
              <a:off x="3792498" y="5833056"/>
              <a:ext cx="1195793" cy="28967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A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n </a:t>
              </a:r>
              <a:r>
                <a:rPr lang="de-AT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nfected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feld 36"/>
            <p:cNvSpPr txBox="1"/>
            <p:nvPr/>
          </p:nvSpPr>
          <p:spPr>
            <a:xfrm>
              <a:off x="1088740" y="8181981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5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2403112" y="8173411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3774310" y="818198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feld 1"/>
          <p:cNvSpPr txBox="1"/>
          <p:nvPr/>
        </p:nvSpPr>
        <p:spPr>
          <a:xfrm>
            <a:off x="233645" y="301460"/>
            <a:ext cx="17700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A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AT" sz="1200" dirty="0" err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de-A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de-A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A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1655476" y="891876"/>
            <a:ext cx="14736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2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uA</a:t>
            </a:r>
            <a:r>
              <a:rPr lang="de-AT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H1N1</a:t>
            </a:r>
            <a:endParaRPr lang="en-GB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06479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Bildschirmpräsentation (4:3)</PresentationFormat>
  <Paragraphs>32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almüller Armin</dc:creator>
  <cp:lastModifiedBy>Saalmüller Armin</cp:lastModifiedBy>
  <cp:revision>49</cp:revision>
  <cp:lastPrinted>2015-07-03T16:43:23Z</cp:lastPrinted>
  <dcterms:created xsi:type="dcterms:W3CDTF">2014-08-05T10:10:54Z</dcterms:created>
  <dcterms:modified xsi:type="dcterms:W3CDTF">2016-06-02T14:47:49Z</dcterms:modified>
</cp:coreProperties>
</file>